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sldIdLst>
    <p:sldId id="256" r:id="rId2"/>
    <p:sldId id="257" r:id="rId3"/>
    <p:sldId id="258" r:id="rId4"/>
    <p:sldId id="259" r:id="rId5"/>
    <p:sldId id="260" r:id="rId6"/>
    <p:sldId id="265" r:id="rId7"/>
    <p:sldId id="266" r:id="rId8"/>
    <p:sldId id="267" r:id="rId9"/>
    <p:sldId id="268" r:id="rId10"/>
    <p:sldId id="269" r:id="rId11"/>
    <p:sldId id="270" r:id="rId12"/>
    <p:sldId id="271" r:id="rId13"/>
    <p:sldId id="272" r:id="rId14"/>
    <p:sldId id="273" r:id="rId15"/>
    <p:sldId id="274" r:id="rId16"/>
    <p:sldId id="275" r:id="rId17"/>
    <p:sldId id="276" r:id="rId18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7" d="100"/>
          <a:sy n="87" d="100"/>
        </p:scale>
        <p:origin x="123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498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331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1507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3512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53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2996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111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586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250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5976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49B1D-8CAE-4A83-972E-931BDC5EB2FB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519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749B1D-8CAE-4A83-972E-931BDC5EB2FB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29BC95-4291-4D91-B19C-F71556F866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3439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18DA01-3C97-46DE-8B26-EEFE491FAD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523" dirty="0"/>
              <a:t>Graphs are presented in </a:t>
            </a:r>
            <a:r>
              <a:rPr lang="en-US" sz="1523" dirty="0"/>
              <a:t>the following order: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FDF977-F630-4927-B5B3-A1AB839ECB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62500" lnSpcReduction="20000"/>
          </a:bodyPr>
          <a:lstStyle/>
          <a:p>
            <a:r>
              <a:rPr lang="en-US" dirty="0"/>
              <a:t>Triangle count </a:t>
            </a:r>
          </a:p>
          <a:p>
            <a:pPr lvl="1"/>
            <a:r>
              <a:rPr lang="en-US" dirty="0" smtClean="0"/>
              <a:t>Prosimian, smoothed, EEC</a:t>
            </a:r>
          </a:p>
          <a:p>
            <a:pPr lvl="1"/>
            <a:r>
              <a:rPr lang="en-US" dirty="0"/>
              <a:t>Prosimian, smoothed, </a:t>
            </a:r>
            <a:r>
              <a:rPr lang="en-US" dirty="0" smtClean="0"/>
              <a:t>BCO</a:t>
            </a:r>
            <a:endParaRPr lang="en-US" dirty="0"/>
          </a:p>
          <a:p>
            <a:pPr lvl="1"/>
            <a:r>
              <a:rPr lang="en-US" dirty="0"/>
              <a:t>Prosimian, </a:t>
            </a:r>
            <a:r>
              <a:rPr lang="en-US" dirty="0" smtClean="0"/>
              <a:t>unsmoothed</a:t>
            </a:r>
            <a:r>
              <a:rPr lang="en-US" dirty="0"/>
              <a:t>, EEC</a:t>
            </a:r>
          </a:p>
          <a:p>
            <a:pPr lvl="1"/>
            <a:r>
              <a:rPr lang="en-US" dirty="0"/>
              <a:t>Prosimian, </a:t>
            </a:r>
            <a:r>
              <a:rPr lang="en-US" dirty="0" smtClean="0"/>
              <a:t>unsmoothed</a:t>
            </a:r>
            <a:r>
              <a:rPr lang="en-US" dirty="0"/>
              <a:t>, BCO</a:t>
            </a:r>
          </a:p>
          <a:p>
            <a:pPr lvl="1"/>
            <a:r>
              <a:rPr lang="en-US" dirty="0" smtClean="0"/>
              <a:t>Platyrrhine, </a:t>
            </a:r>
            <a:r>
              <a:rPr lang="en-US" dirty="0"/>
              <a:t>smoothed, EEC</a:t>
            </a:r>
          </a:p>
          <a:p>
            <a:pPr lvl="1"/>
            <a:r>
              <a:rPr lang="en-US" dirty="0"/>
              <a:t>Platyrrhine</a:t>
            </a:r>
            <a:r>
              <a:rPr lang="en-US" dirty="0" smtClean="0"/>
              <a:t>, </a:t>
            </a:r>
            <a:r>
              <a:rPr lang="en-US" dirty="0"/>
              <a:t>smoothed, BCO</a:t>
            </a:r>
          </a:p>
          <a:p>
            <a:pPr lvl="1"/>
            <a:r>
              <a:rPr lang="en-US" dirty="0"/>
              <a:t>Platyrrhine</a:t>
            </a:r>
            <a:r>
              <a:rPr lang="en-US" dirty="0" smtClean="0"/>
              <a:t>, </a:t>
            </a:r>
            <a:r>
              <a:rPr lang="en-US" dirty="0"/>
              <a:t>unsmoothed, EEC</a:t>
            </a:r>
          </a:p>
          <a:p>
            <a:pPr lvl="1"/>
            <a:r>
              <a:rPr lang="en-US" dirty="0"/>
              <a:t>Platyrrhine</a:t>
            </a:r>
            <a:r>
              <a:rPr lang="en-US" dirty="0" smtClean="0"/>
              <a:t>, </a:t>
            </a:r>
            <a:r>
              <a:rPr lang="en-US" dirty="0"/>
              <a:t>unsmoothed, BCO</a:t>
            </a:r>
          </a:p>
          <a:p>
            <a:r>
              <a:rPr lang="en-US" dirty="0" smtClean="0"/>
              <a:t>Resolution</a:t>
            </a:r>
            <a:endParaRPr lang="en-US" dirty="0"/>
          </a:p>
          <a:p>
            <a:pPr lvl="1"/>
            <a:r>
              <a:rPr lang="en-US" dirty="0"/>
              <a:t>Prosimian, smoothed, EEC</a:t>
            </a:r>
          </a:p>
          <a:p>
            <a:pPr lvl="1"/>
            <a:r>
              <a:rPr lang="en-US" dirty="0"/>
              <a:t>Prosimian, smoothed, BCO</a:t>
            </a:r>
          </a:p>
          <a:p>
            <a:pPr lvl="1"/>
            <a:r>
              <a:rPr lang="en-US" dirty="0"/>
              <a:t>Prosimian, unsmoothed, EEC</a:t>
            </a:r>
          </a:p>
          <a:p>
            <a:pPr lvl="1"/>
            <a:r>
              <a:rPr lang="en-US" dirty="0"/>
              <a:t>Prosimian, unsmoothed, BCO</a:t>
            </a:r>
          </a:p>
          <a:p>
            <a:pPr lvl="1"/>
            <a:r>
              <a:rPr lang="en-US" dirty="0"/>
              <a:t>Platyrrhine, smoothed, EEC</a:t>
            </a:r>
          </a:p>
          <a:p>
            <a:pPr lvl="1"/>
            <a:r>
              <a:rPr lang="en-US" dirty="0"/>
              <a:t>Platyrrhine, smoothed, BCO</a:t>
            </a:r>
          </a:p>
          <a:p>
            <a:pPr lvl="1"/>
            <a:r>
              <a:rPr lang="en-US" dirty="0"/>
              <a:t>Platyrrhine, unsmoothed, EEC</a:t>
            </a:r>
          </a:p>
          <a:p>
            <a:pPr lvl="1"/>
            <a:r>
              <a:rPr lang="en-US" dirty="0"/>
              <a:t>Platyrrhine, unsmoothed, BCO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93067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938" dirty="0"/>
              <a:t>Resolution, prosimian, </a:t>
            </a:r>
            <a:r>
              <a:rPr lang="en-US" sz="1938" dirty="0"/>
              <a:t>smoothed, EEC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40" y="2029792"/>
            <a:ext cx="5913120" cy="3943004"/>
          </a:xfrm>
        </p:spPr>
      </p:pic>
    </p:spTree>
    <p:extLst>
      <p:ext uri="{BB962C8B-B14F-4D97-AF65-F5344CB8AC3E}">
        <p14:creationId xmlns:p14="http://schemas.microsoft.com/office/powerpoint/2010/main" val="94044989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938" dirty="0"/>
              <a:t>Resolution, prosimian, smoothed</a:t>
            </a:r>
            <a:r>
              <a:rPr lang="en-US" sz="1938" dirty="0"/>
              <a:t>, BCO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40" y="2029792"/>
            <a:ext cx="5913120" cy="3943004"/>
          </a:xfrm>
        </p:spPr>
      </p:pic>
    </p:spTree>
    <p:extLst>
      <p:ext uri="{BB962C8B-B14F-4D97-AF65-F5344CB8AC3E}">
        <p14:creationId xmlns:p14="http://schemas.microsoft.com/office/powerpoint/2010/main" val="84109607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938" dirty="0"/>
              <a:t>Resolution, prosimian, unsmoothed</a:t>
            </a:r>
            <a:r>
              <a:rPr lang="en-US" sz="1938" dirty="0"/>
              <a:t>, EEC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40" y="2029792"/>
            <a:ext cx="5913120" cy="3943004"/>
          </a:xfrm>
        </p:spPr>
      </p:pic>
    </p:spTree>
    <p:extLst>
      <p:ext uri="{BB962C8B-B14F-4D97-AF65-F5344CB8AC3E}">
        <p14:creationId xmlns:p14="http://schemas.microsoft.com/office/powerpoint/2010/main" val="248720206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938" dirty="0"/>
              <a:t>Resolution, prosimian, unsmoothed</a:t>
            </a:r>
            <a:r>
              <a:rPr lang="en-US" sz="1938" dirty="0"/>
              <a:t>, BCO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40" y="2029792"/>
            <a:ext cx="5913120" cy="3943004"/>
          </a:xfrm>
        </p:spPr>
      </p:pic>
    </p:spTree>
    <p:extLst>
      <p:ext uri="{BB962C8B-B14F-4D97-AF65-F5344CB8AC3E}">
        <p14:creationId xmlns:p14="http://schemas.microsoft.com/office/powerpoint/2010/main" val="140423561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938" dirty="0"/>
              <a:t>Resolution, platyrrhine, </a:t>
            </a:r>
            <a:r>
              <a:rPr lang="en-US" sz="1938" dirty="0"/>
              <a:t>smoothed, EEC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40" y="2029792"/>
            <a:ext cx="5913120" cy="3943004"/>
          </a:xfrm>
        </p:spPr>
      </p:pic>
    </p:spTree>
    <p:extLst>
      <p:ext uri="{BB962C8B-B14F-4D97-AF65-F5344CB8AC3E}">
        <p14:creationId xmlns:p14="http://schemas.microsoft.com/office/powerpoint/2010/main" val="35944392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938" dirty="0"/>
              <a:t>Resolution, platyrrhine, smoothed</a:t>
            </a:r>
            <a:r>
              <a:rPr lang="en-US" sz="1938" dirty="0"/>
              <a:t>, BCO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40" y="2029792"/>
            <a:ext cx="5913120" cy="3943004"/>
          </a:xfrm>
        </p:spPr>
      </p:pic>
    </p:spTree>
    <p:extLst>
      <p:ext uri="{BB962C8B-B14F-4D97-AF65-F5344CB8AC3E}">
        <p14:creationId xmlns:p14="http://schemas.microsoft.com/office/powerpoint/2010/main" val="1489427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938" dirty="0"/>
              <a:t>Resolution, platyrrhine, unsmoothed</a:t>
            </a:r>
            <a:r>
              <a:rPr lang="en-US" sz="1938" dirty="0"/>
              <a:t>, EEC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40" y="2029792"/>
            <a:ext cx="5913120" cy="3943004"/>
          </a:xfrm>
        </p:spPr>
      </p:pic>
    </p:spTree>
    <p:extLst>
      <p:ext uri="{BB962C8B-B14F-4D97-AF65-F5344CB8AC3E}">
        <p14:creationId xmlns:p14="http://schemas.microsoft.com/office/powerpoint/2010/main" val="177683157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938" dirty="0"/>
              <a:t>Resolution, platyrrhine, unsmoothed</a:t>
            </a:r>
            <a:r>
              <a:rPr lang="en-US" sz="1938" dirty="0"/>
              <a:t>, BCO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40" y="2029792"/>
            <a:ext cx="5913120" cy="3943004"/>
          </a:xfrm>
        </p:spPr>
      </p:pic>
    </p:spTree>
    <p:extLst>
      <p:ext uri="{BB962C8B-B14F-4D97-AF65-F5344CB8AC3E}">
        <p14:creationId xmlns:p14="http://schemas.microsoft.com/office/powerpoint/2010/main" val="39208778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938" dirty="0"/>
              <a:t>Triangle count</a:t>
            </a:r>
            <a:r>
              <a:rPr lang="en-US" sz="1938" dirty="0"/>
              <a:t>, prosimian, </a:t>
            </a:r>
            <a:r>
              <a:rPr lang="en-US" sz="1938" dirty="0"/>
              <a:t>smoothed, EEC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40" y="2029792"/>
            <a:ext cx="5913120" cy="3943004"/>
          </a:xfrm>
        </p:spPr>
      </p:pic>
    </p:spTree>
    <p:extLst>
      <p:ext uri="{BB962C8B-B14F-4D97-AF65-F5344CB8AC3E}">
        <p14:creationId xmlns:p14="http://schemas.microsoft.com/office/powerpoint/2010/main" val="15440611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938" dirty="0"/>
              <a:t>Triangle count, </a:t>
            </a:r>
            <a:r>
              <a:rPr lang="en-US" sz="1938" dirty="0"/>
              <a:t>prosimian, smoothed</a:t>
            </a:r>
            <a:r>
              <a:rPr lang="en-US" sz="1938" dirty="0"/>
              <a:t>, BCO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40" y="2029792"/>
            <a:ext cx="5913120" cy="3943004"/>
          </a:xfrm>
        </p:spPr>
      </p:pic>
    </p:spTree>
    <p:extLst>
      <p:ext uri="{BB962C8B-B14F-4D97-AF65-F5344CB8AC3E}">
        <p14:creationId xmlns:p14="http://schemas.microsoft.com/office/powerpoint/2010/main" val="17804102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938" dirty="0"/>
              <a:t>Triangle count, </a:t>
            </a:r>
            <a:r>
              <a:rPr lang="en-US" sz="1938" dirty="0"/>
              <a:t>prosimian, unsmoothed</a:t>
            </a:r>
            <a:r>
              <a:rPr lang="en-US" sz="1938" dirty="0"/>
              <a:t>, EEC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40" y="2029792"/>
            <a:ext cx="5913120" cy="3943004"/>
          </a:xfrm>
        </p:spPr>
      </p:pic>
    </p:spTree>
    <p:extLst>
      <p:ext uri="{BB962C8B-B14F-4D97-AF65-F5344CB8AC3E}">
        <p14:creationId xmlns:p14="http://schemas.microsoft.com/office/powerpoint/2010/main" val="16868475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938" dirty="0"/>
              <a:t>Triangle count, </a:t>
            </a:r>
            <a:r>
              <a:rPr lang="en-US" sz="1938" dirty="0"/>
              <a:t>prosimian, unsmoothed</a:t>
            </a:r>
            <a:r>
              <a:rPr lang="en-US" sz="1938" dirty="0"/>
              <a:t>, BCO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40" y="2029792"/>
            <a:ext cx="5913120" cy="3943004"/>
          </a:xfrm>
        </p:spPr>
      </p:pic>
    </p:spTree>
    <p:extLst>
      <p:ext uri="{BB962C8B-B14F-4D97-AF65-F5344CB8AC3E}">
        <p14:creationId xmlns:p14="http://schemas.microsoft.com/office/powerpoint/2010/main" val="15381380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938" dirty="0"/>
              <a:t>Triangle count</a:t>
            </a:r>
            <a:r>
              <a:rPr lang="en-US" sz="1938" dirty="0"/>
              <a:t>, platyrrhine, </a:t>
            </a:r>
            <a:r>
              <a:rPr lang="en-US" sz="1938" dirty="0"/>
              <a:t>smoothed, EEC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40" y="2029792"/>
            <a:ext cx="5913120" cy="3943004"/>
          </a:xfrm>
        </p:spPr>
      </p:pic>
    </p:spTree>
    <p:extLst>
      <p:ext uri="{BB962C8B-B14F-4D97-AF65-F5344CB8AC3E}">
        <p14:creationId xmlns:p14="http://schemas.microsoft.com/office/powerpoint/2010/main" val="10467584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938" dirty="0"/>
              <a:t>Triangle count, </a:t>
            </a:r>
            <a:r>
              <a:rPr lang="en-US" sz="1938" dirty="0"/>
              <a:t>platyrrhine, smoothed</a:t>
            </a:r>
            <a:r>
              <a:rPr lang="en-US" sz="1938" dirty="0"/>
              <a:t>, BCO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40" y="2029792"/>
            <a:ext cx="5913120" cy="3943004"/>
          </a:xfrm>
        </p:spPr>
      </p:pic>
    </p:spTree>
    <p:extLst>
      <p:ext uri="{BB962C8B-B14F-4D97-AF65-F5344CB8AC3E}">
        <p14:creationId xmlns:p14="http://schemas.microsoft.com/office/powerpoint/2010/main" val="37605417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938" dirty="0"/>
              <a:t>Triangle count, </a:t>
            </a:r>
            <a:r>
              <a:rPr lang="en-US" sz="1938" dirty="0"/>
              <a:t>platyrrhine, unsmoothed</a:t>
            </a:r>
            <a:r>
              <a:rPr lang="en-US" sz="1938" dirty="0"/>
              <a:t>, EEC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40" y="2029792"/>
            <a:ext cx="5913120" cy="3943004"/>
          </a:xfrm>
        </p:spPr>
      </p:pic>
    </p:spTree>
    <p:extLst>
      <p:ext uri="{BB962C8B-B14F-4D97-AF65-F5344CB8AC3E}">
        <p14:creationId xmlns:p14="http://schemas.microsoft.com/office/powerpoint/2010/main" val="270777031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24E0643-9480-42DF-B6B0-11CEBACA8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938" dirty="0"/>
              <a:t>Triangle count, </a:t>
            </a:r>
            <a:r>
              <a:rPr lang="en-US" sz="1938" dirty="0"/>
              <a:t>platyrrhine, unsmoothed</a:t>
            </a:r>
            <a:r>
              <a:rPr lang="en-US" sz="1938" dirty="0"/>
              <a:t>, BCO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40" y="2029792"/>
            <a:ext cx="5913120" cy="3943004"/>
          </a:xfrm>
        </p:spPr>
      </p:pic>
    </p:spTree>
    <p:extLst>
      <p:ext uri="{BB962C8B-B14F-4D97-AF65-F5344CB8AC3E}">
        <p14:creationId xmlns:p14="http://schemas.microsoft.com/office/powerpoint/2010/main" val="30530933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1</TotalTime>
  <Words>211</Words>
  <Application>Microsoft Office PowerPoint</Application>
  <PresentationFormat>A4 Paper (210x297 mm)</PresentationFormat>
  <Paragraphs>35</Paragraphs>
  <Slides>1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1" baseType="lpstr">
      <vt:lpstr>Arial</vt:lpstr>
      <vt:lpstr>Calibri</vt:lpstr>
      <vt:lpstr>Calibri Light</vt:lpstr>
      <vt:lpstr>Office Theme</vt:lpstr>
      <vt:lpstr>Graphs are presented in the following order:</vt:lpstr>
      <vt:lpstr>Triangle count, prosimian, smoothed, EEC</vt:lpstr>
      <vt:lpstr>Triangle count, prosimian, smoothed, BCO</vt:lpstr>
      <vt:lpstr>Triangle count, prosimian, unsmoothed, EEC</vt:lpstr>
      <vt:lpstr>Triangle count, prosimian, unsmoothed, BCO</vt:lpstr>
      <vt:lpstr>Triangle count, platyrrhine, smoothed, EEC</vt:lpstr>
      <vt:lpstr>Triangle count, platyrrhine, smoothed, BCO</vt:lpstr>
      <vt:lpstr>Triangle count, platyrrhine, unsmoothed, EEC</vt:lpstr>
      <vt:lpstr>Triangle count, platyrrhine, unsmoothed, BCO</vt:lpstr>
      <vt:lpstr>Resolution, prosimian, smoothed, EEC</vt:lpstr>
      <vt:lpstr>Resolution, prosimian, smoothed, BCO</vt:lpstr>
      <vt:lpstr>Resolution, prosimian, unsmoothed, EEC</vt:lpstr>
      <vt:lpstr>Resolution, prosimian, unsmoothed, BCO</vt:lpstr>
      <vt:lpstr>Resolution, platyrrhine, smoothed, EEC</vt:lpstr>
      <vt:lpstr>Resolution, platyrrhine, smoothed, BCO</vt:lpstr>
      <vt:lpstr>Resolution, platyrrhine, unsmoothed, EEC</vt:lpstr>
      <vt:lpstr>Resolution, platyrrhine, unsmoothed, BCO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Berthaume</dc:creator>
  <cp:lastModifiedBy>Berthaume, Michael</cp:lastModifiedBy>
  <cp:revision>16</cp:revision>
  <dcterms:created xsi:type="dcterms:W3CDTF">2018-01-19T20:31:50Z</dcterms:created>
  <dcterms:modified xsi:type="dcterms:W3CDTF">2018-08-02T17:55:19Z</dcterms:modified>
</cp:coreProperties>
</file>